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589" y="-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494BDC-55A3-4BA8-8179-A1E1E6EBEC2C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3934C4-1469-406F-9BD4-BF976DD055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51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102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25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384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737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435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007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254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927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208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730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878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277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6" name="Table 3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4823518"/>
              </p:ext>
            </p:extLst>
          </p:nvPr>
        </p:nvGraphicFramePr>
        <p:xfrm>
          <a:off x="49428" y="539552"/>
          <a:ext cx="6741369" cy="3693569"/>
        </p:xfrm>
        <a:graphic>
          <a:graphicData uri="http://schemas.openxmlformats.org/drawingml/2006/table">
            <a:tbl>
              <a:tblPr bandRow="1">
                <a:tableStyleId>{8EC20E35-A176-4012-BC5E-935CFFF8708E}</a:tableStyleId>
              </a:tblPr>
              <a:tblGrid>
                <a:gridCol w="1419235"/>
                <a:gridCol w="793102"/>
                <a:gridCol w="1144656"/>
                <a:gridCol w="1057247"/>
                <a:gridCol w="2327129"/>
              </a:tblGrid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Clinical Variable</a:t>
                      </a:r>
                      <a:endParaRPr lang="en-GB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Odds ratio</a:t>
                      </a:r>
                      <a:endParaRPr lang="en-GB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95% Confidence </a:t>
                      </a:r>
                      <a:r>
                        <a:rPr lang="en-GB" sz="1200" b="1" u="none" strike="noStrike" dirty="0" smtClean="0">
                          <a:effectLst/>
                        </a:rPr>
                        <a:t>Interval Lower</a:t>
                      </a:r>
                      <a:endParaRPr lang="en-GB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1" u="none" strike="noStrike" dirty="0" smtClean="0">
                          <a:effectLst/>
                        </a:rPr>
                        <a:t>95% Confidence Interval Upper</a:t>
                      </a:r>
                      <a:endParaRPr lang="en-GB" sz="1200" b="1" i="0" u="none" strike="noStrike" dirty="0" smtClean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733" marR="5733" marT="573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Univariate Logistic Regression Significance</a:t>
                      </a:r>
                      <a:endParaRPr lang="en-GB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</a:rPr>
                        <a:t>Gender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601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151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2.390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470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</a:rPr>
                        <a:t>Ethnicity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831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94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2.34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727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Age (years)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610" marR="6610" marT="66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.02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0.97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.07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39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FEV1 % predicted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610" marR="6610" marT="66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01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97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06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38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FVC % predicted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610" marR="6610" marT="66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00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96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06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74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FEV1/FVC % predicted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610" marR="6610" marT="66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00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99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00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27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KCO % predicted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610" marR="6610" marT="66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00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97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03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77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TLCO % predicted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610" marR="6610" marT="66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99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95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03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82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Length of disease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610" marR="6610" marT="66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99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98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01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53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</a:rPr>
                        <a:t>Biopsy site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1.12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544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2.341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745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</a:rPr>
                        <a:t>Other organs involved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2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374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10.691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418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</a:rPr>
                        <a:t>Scadding stage 1-4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1.054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580</a:t>
                      </a: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91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50" u="none" strike="noStrike" dirty="0" smtClean="0">
                          <a:effectLst/>
                        </a:rPr>
                        <a:t>0.862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</a:rPr>
                        <a:t>Scadding stage 1/4 or 2/3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4.444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510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38.73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177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solidFill>
                            <a:schemeClr val="tx1"/>
                          </a:solidFill>
                          <a:effectLst/>
                        </a:rPr>
                        <a:t>HRCT disease activity</a:t>
                      </a:r>
                      <a:endParaRPr lang="en-GB" sz="105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10.417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1.75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61.672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010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solidFill>
                            <a:schemeClr val="tx1"/>
                          </a:solidFill>
                          <a:effectLst/>
                        </a:rPr>
                        <a:t>Respiratory symptoms</a:t>
                      </a:r>
                      <a:endParaRPr lang="en-GB" sz="105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5.6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48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.424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8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Serum ACE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610" marR="6610" marT="66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.01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00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.03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0.03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solidFill>
                            <a:schemeClr val="tx1"/>
                          </a:solidFill>
                          <a:effectLst/>
                        </a:rPr>
                        <a:t>Neutrophil count</a:t>
                      </a:r>
                      <a:endParaRPr lang="en-GB" sz="105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48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82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.67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18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solidFill>
                            <a:schemeClr val="tx1"/>
                          </a:solidFill>
                          <a:effectLst/>
                        </a:rPr>
                        <a:t>Lymphocyte count</a:t>
                      </a:r>
                      <a:endParaRPr lang="en-GB" sz="105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05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00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32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00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solidFill>
                            <a:schemeClr val="tx1"/>
                          </a:solidFill>
                          <a:effectLst/>
                        </a:rPr>
                        <a:t>Commenced treatment</a:t>
                      </a:r>
                      <a:endParaRPr lang="en-GB" sz="105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8.571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0.99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73.573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0.050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</a:tr>
              <a:tr h="1375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solidFill>
                            <a:schemeClr val="tx1"/>
                          </a:solidFill>
                          <a:effectLst/>
                        </a:rPr>
                        <a:t>Clinical </a:t>
                      </a:r>
                      <a:r>
                        <a:rPr lang="en-GB" sz="105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decision</a:t>
                      </a:r>
                      <a:r>
                        <a:rPr lang="en-GB" sz="1050" u="none" strike="noStrike" baseline="0" dirty="0" smtClean="0">
                          <a:solidFill>
                            <a:schemeClr val="tx1"/>
                          </a:solidFill>
                          <a:effectLst/>
                        </a:rPr>
                        <a:t> tree</a:t>
                      </a:r>
                      <a:endParaRPr lang="en-GB" sz="105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5733" marR="5733" marT="57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17.438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3.129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97.189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0.001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graphicFrame>
        <p:nvGraphicFramePr>
          <p:cNvPr id="38" name="Table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6397819"/>
              </p:ext>
            </p:extLst>
          </p:nvPr>
        </p:nvGraphicFramePr>
        <p:xfrm>
          <a:off x="34938" y="4932040"/>
          <a:ext cx="6785991" cy="1525612"/>
        </p:xfrm>
        <a:graphic>
          <a:graphicData uri="http://schemas.openxmlformats.org/drawingml/2006/table">
            <a:tbl>
              <a:tblPr firstRow="1"/>
              <a:tblGrid>
                <a:gridCol w="1419012"/>
                <a:gridCol w="792975"/>
                <a:gridCol w="1331482"/>
                <a:gridCol w="1080841"/>
                <a:gridCol w="2161681"/>
              </a:tblGrid>
              <a:tr h="1191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inical Variable</a:t>
                      </a:r>
                    </a:p>
                  </a:txBody>
                  <a:tcPr marL="4964" marR="4964" marT="49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dds ratio</a:t>
                      </a:r>
                    </a:p>
                  </a:txBody>
                  <a:tcPr marL="4964" marR="4964" marT="49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5% Confidence Lower Interval</a:t>
                      </a:r>
                    </a:p>
                  </a:txBody>
                  <a:tcPr marL="4964" marR="4964" marT="49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5% Confidence Upper </a:t>
                      </a:r>
                      <a:r>
                        <a:rPr lang="en-GB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terval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ultivariate Logistic Regression Significance</a:t>
                      </a:r>
                    </a:p>
                  </a:txBody>
                  <a:tcPr marL="4964" marR="4964" marT="49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91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rum ACE</a:t>
                      </a: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35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2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6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6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91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ymphocyte count</a:t>
                      </a: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6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3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48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2</a:t>
                      </a: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91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RCT disease activity</a:t>
                      </a: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82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20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5.335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57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91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rum ACE</a:t>
                      </a: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39</a:t>
                      </a: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0</a:t>
                      </a: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83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1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ymphocyte count</a:t>
                      </a: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8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51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6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91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inical </a:t>
                      </a:r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cision</a:t>
                      </a:r>
                      <a:r>
                        <a:rPr lang="en-GB" sz="105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tree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604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47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1.213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8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91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ymphocyte count</a:t>
                      </a: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33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4</a:t>
                      </a: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3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8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964" marR="4964" marT="49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7341" y="107504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4A</a:t>
            </a:r>
            <a:endParaRPr lang="en-GB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1574" y="4562708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4B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8371633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17</Words>
  <Application>Microsoft Office PowerPoint</Application>
  <PresentationFormat>On-screen Show (4:3)</PresentationFormat>
  <Paragraphs>14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om</dc:creator>
  <cp:lastModifiedBy>Bloom</cp:lastModifiedBy>
  <cp:revision>5</cp:revision>
  <dcterms:created xsi:type="dcterms:W3CDTF">2013-03-09T22:22:05Z</dcterms:created>
  <dcterms:modified xsi:type="dcterms:W3CDTF">2013-03-09T22:26:16Z</dcterms:modified>
</cp:coreProperties>
</file>